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tableStyles+xml" PartName="/ppt/tableStyles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autoCompressPictures="0" strictFirstAndLastChars="0" saveSubsetFonts="1">
  <p:sldMasterIdLst>
    <p:sldMasterId id="2147483659" r:id="rId4"/>
  </p:sldMasterIdLst>
  <p:notesMasterIdLst>
    <p:notesMasterId r:id="rId5"/>
  </p:notesMasterIdLst>
  <p:sldIdLst>
    <p:sldId id="256" r:id="rId6"/>
  </p:sldIdLst>
  <p:sldSz cy="5943600" cx="146304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/>
</file>

<file path=ppt/tableStyles.xml><?xml version="1.0" encoding="utf-8"?>
<a:tblStyleLst xmlns:a="http://schemas.openxmlformats.org/drawingml/2006/main" xmlns:r="http://schemas.openxmlformats.org/officeDocument/2006/relationships" def="{23C1CB89-ECA3-4FAA-A7E1-106BF05B6F16}">
  <a:tblStyle styleId="{23C1CB89-ECA3-4FAA-A7E1-106BF05B6F16}" styleName="Table_0">
    <a:wholeTbl>
      <a:tcTxStyle>
        <a:font>
          <a:latin typeface="Arial"/>
          <a:ea typeface="Arial"/>
          <a:cs typeface="Arial"/>
        </a:font>
        <a:srgbClr val="000000"/>
      </a:tcTxStyle>
    </a:wholeTbl>
    <a:band1H>
      <a:tcTxStyle/>
    </a:band1H>
    <a:band2H>
      <a:tcTxStyle/>
    </a:band2H>
    <a:band1V>
      <a:tcTxStyle/>
    </a:band1V>
    <a:band2V>
      <a:tcTxStyle/>
    </a:band2V>
    <a:lastCol>
      <a:tcTxStyle/>
    </a:lastCol>
    <a:firstCol>
      <a:tcTxStyle/>
    </a:firstCol>
    <a:lastRow>
      <a:tcTxStyle/>
    </a:lastRow>
    <a:seCell>
      <a:tcTxStyle/>
    </a:seCell>
    <a:swCell>
      <a:tcTxStyle/>
    </a:swCell>
    <a:firstRow>
      <a:tcTxStyle/>
    </a:firstRow>
    <a:neCell>
      <a:tcTxStyle/>
    </a:neCell>
    <a:nwCell>
      <a:tcTxStyle/>
    </a:nwCell>
  </a:tblStyle>
</a:tblStyleLst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presProps" Target="presProps.xml"/><Relationship Id="rId3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showMasterPhAnim="0" showMasterSp="0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2" name="Google Shape;82;p1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Blank" type="blank">
  <p:cSld name="BLANK">
    <p:spTree>
      <p:nvGrpSpPr>
        <p:cNvPr id="1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2"/>
          <p:cNvSpPr txBox="1"/>
          <p:nvPr>
            <p:ph idx="10" type="dt"/>
          </p:nvPr>
        </p:nvSpPr>
        <p:spPr>
          <a:xfrm>
            <a:off x="100584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" name="Google Shape;13;p2"/>
          <p:cNvSpPr txBox="1"/>
          <p:nvPr>
            <p:ph idx="11" type="ftr"/>
          </p:nvPr>
        </p:nvSpPr>
        <p:spPr>
          <a:xfrm>
            <a:off x="4846320" y="5508837"/>
            <a:ext cx="493776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4" name="Google Shape;14;p2"/>
          <p:cNvSpPr txBox="1"/>
          <p:nvPr>
            <p:ph idx="12" type="sldNum"/>
          </p:nvPr>
        </p:nvSpPr>
        <p:spPr>
          <a:xfrm>
            <a:off x="1033272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Title and Vertical Text" type="vertTx">
  <p:cSld name="VERTICAL_TEXT"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1"/>
          <p:cNvSpPr txBox="1"/>
          <p:nvPr>
            <p:ph type="title"/>
          </p:nvPr>
        </p:nvSpPr>
        <p:spPr>
          <a:xfrm>
            <a:off x="1005840" y="316442"/>
            <a:ext cx="12618721" cy="114882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11"/>
          <p:cNvSpPr txBox="1"/>
          <p:nvPr>
            <p:ph idx="1" type="body"/>
          </p:nvPr>
        </p:nvSpPr>
        <p:spPr>
          <a:xfrm rot="5400000">
            <a:off x="5429619" y="-2841572"/>
            <a:ext cx="3771160" cy="12618721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342900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1" name="Google Shape;71;p11"/>
          <p:cNvSpPr txBox="1"/>
          <p:nvPr>
            <p:ph idx="10" type="dt"/>
          </p:nvPr>
        </p:nvSpPr>
        <p:spPr>
          <a:xfrm>
            <a:off x="100584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2" name="Google Shape;72;p11"/>
          <p:cNvSpPr txBox="1"/>
          <p:nvPr>
            <p:ph idx="11" type="ftr"/>
          </p:nvPr>
        </p:nvSpPr>
        <p:spPr>
          <a:xfrm>
            <a:off x="4846320" y="5508837"/>
            <a:ext cx="493776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3" name="Google Shape;73;p11"/>
          <p:cNvSpPr txBox="1"/>
          <p:nvPr>
            <p:ph idx="12" type="sldNum"/>
          </p:nvPr>
        </p:nvSpPr>
        <p:spPr>
          <a:xfrm>
            <a:off x="1033272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Vertical Title and Text" type="vertTitleAndTx">
  <p:cSld name="VERTICAL_TITLE_AND_VERTICAL_TEXT"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2"/>
          <p:cNvSpPr txBox="1"/>
          <p:nvPr>
            <p:ph type="title"/>
          </p:nvPr>
        </p:nvSpPr>
        <p:spPr>
          <a:xfrm rot="5400000">
            <a:off x="9528756" y="1257565"/>
            <a:ext cx="5036926" cy="315468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12"/>
          <p:cNvSpPr txBox="1"/>
          <p:nvPr>
            <p:ph idx="1" type="body"/>
          </p:nvPr>
        </p:nvSpPr>
        <p:spPr>
          <a:xfrm rot="5400000">
            <a:off x="3127957" y="-1805675"/>
            <a:ext cx="5036926" cy="928116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342900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7" name="Google Shape;77;p12"/>
          <p:cNvSpPr txBox="1"/>
          <p:nvPr>
            <p:ph idx="10" type="dt"/>
          </p:nvPr>
        </p:nvSpPr>
        <p:spPr>
          <a:xfrm>
            <a:off x="100584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8" name="Google Shape;78;p12"/>
          <p:cNvSpPr txBox="1"/>
          <p:nvPr>
            <p:ph idx="11" type="ftr"/>
          </p:nvPr>
        </p:nvSpPr>
        <p:spPr>
          <a:xfrm>
            <a:off x="4846320" y="5508837"/>
            <a:ext cx="493776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9" name="Google Shape;79;p12"/>
          <p:cNvSpPr txBox="1"/>
          <p:nvPr>
            <p:ph idx="12" type="sldNum"/>
          </p:nvPr>
        </p:nvSpPr>
        <p:spPr>
          <a:xfrm>
            <a:off x="1033272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Title Slide" type="title">
  <p:cSld name="TITLE">
    <p:spTree>
      <p:nvGrpSpPr>
        <p:cNvPr id="15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3"/>
          <p:cNvSpPr txBox="1"/>
          <p:nvPr>
            <p:ph type="ctrTitle"/>
          </p:nvPr>
        </p:nvSpPr>
        <p:spPr>
          <a:xfrm>
            <a:off x="1828800" y="972715"/>
            <a:ext cx="10972800" cy="2069253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200"/>
              <a:buFont typeface="Calibri"/>
              <a:buNone/>
              <a:defRPr sz="5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" name="Google Shape;17;p3"/>
          <p:cNvSpPr txBox="1"/>
          <p:nvPr>
            <p:ph idx="1" type="subTitle"/>
          </p:nvPr>
        </p:nvSpPr>
        <p:spPr>
          <a:xfrm>
            <a:off x="1828800" y="3121766"/>
            <a:ext cx="10972800" cy="143499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lvl="0" algn="ctr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2080"/>
              <a:buNone/>
              <a:defRPr sz="2080"/>
            </a:lvl1pPr>
            <a:lvl2pPr lvl="1" algn="ctr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None/>
              <a:defRPr sz="1733"/>
            </a:lvl2pPr>
            <a:lvl3pPr lvl="2" algn="ctr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560"/>
              <a:buNone/>
              <a:defRPr sz="1560"/>
            </a:lvl3pPr>
            <a:lvl4pPr lvl="3" algn="ctr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sz="1387"/>
            </a:lvl4pPr>
            <a:lvl5pPr lvl="4" algn="ctr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sz="1387"/>
            </a:lvl5pPr>
            <a:lvl6pPr lvl="5" algn="ctr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sz="1387"/>
            </a:lvl6pPr>
            <a:lvl7pPr lvl="6" algn="ctr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sz="1387"/>
            </a:lvl7pPr>
            <a:lvl8pPr lvl="7" algn="ctr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sz="1387"/>
            </a:lvl8pPr>
            <a:lvl9pPr lvl="8" algn="ctr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sz="1387"/>
            </a:lvl9pPr>
          </a:lstStyle>
          <a:p/>
        </p:txBody>
      </p:sp>
      <p:sp>
        <p:nvSpPr>
          <p:cNvPr id="18" name="Google Shape;18;p3"/>
          <p:cNvSpPr txBox="1"/>
          <p:nvPr>
            <p:ph idx="10" type="dt"/>
          </p:nvPr>
        </p:nvSpPr>
        <p:spPr>
          <a:xfrm>
            <a:off x="100584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" name="Google Shape;19;p3"/>
          <p:cNvSpPr txBox="1"/>
          <p:nvPr>
            <p:ph idx="11" type="ftr"/>
          </p:nvPr>
        </p:nvSpPr>
        <p:spPr>
          <a:xfrm>
            <a:off x="4846320" y="5508837"/>
            <a:ext cx="493776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0" name="Google Shape;20;p3"/>
          <p:cNvSpPr txBox="1"/>
          <p:nvPr>
            <p:ph idx="12" type="sldNum"/>
          </p:nvPr>
        </p:nvSpPr>
        <p:spPr>
          <a:xfrm>
            <a:off x="1033272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Title and Content" type="obj">
  <p:cSld name="OBJECT">
    <p:spTree>
      <p:nvGrpSpPr>
        <p:cNvPr id="2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4"/>
          <p:cNvSpPr txBox="1"/>
          <p:nvPr>
            <p:ph type="title"/>
          </p:nvPr>
        </p:nvSpPr>
        <p:spPr>
          <a:xfrm>
            <a:off x="1005840" y="316442"/>
            <a:ext cx="12618721" cy="114882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3" name="Google Shape;23;p4"/>
          <p:cNvSpPr txBox="1"/>
          <p:nvPr>
            <p:ph idx="1" type="body"/>
          </p:nvPr>
        </p:nvSpPr>
        <p:spPr>
          <a:xfrm>
            <a:off x="1005840" y="1582208"/>
            <a:ext cx="12618721" cy="377116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342900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4" name="Google Shape;24;p4"/>
          <p:cNvSpPr txBox="1"/>
          <p:nvPr>
            <p:ph idx="10" type="dt"/>
          </p:nvPr>
        </p:nvSpPr>
        <p:spPr>
          <a:xfrm>
            <a:off x="100584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5" name="Google Shape;25;p4"/>
          <p:cNvSpPr txBox="1"/>
          <p:nvPr>
            <p:ph idx="11" type="ftr"/>
          </p:nvPr>
        </p:nvSpPr>
        <p:spPr>
          <a:xfrm>
            <a:off x="4846320" y="5508837"/>
            <a:ext cx="493776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6" name="Google Shape;26;p4"/>
          <p:cNvSpPr txBox="1"/>
          <p:nvPr>
            <p:ph idx="12" type="sldNum"/>
          </p:nvPr>
        </p:nvSpPr>
        <p:spPr>
          <a:xfrm>
            <a:off x="1033272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Section Header" type="secHead">
  <p:cSld name="SECTION_HEADER">
    <p:spTree>
      <p:nvGrpSpPr>
        <p:cNvPr id="27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5"/>
          <p:cNvSpPr txBox="1"/>
          <p:nvPr>
            <p:ph type="title"/>
          </p:nvPr>
        </p:nvSpPr>
        <p:spPr>
          <a:xfrm>
            <a:off x="998220" y="1481773"/>
            <a:ext cx="12618721" cy="247237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200"/>
              <a:buFont typeface="Calibri"/>
              <a:buNone/>
              <a:defRPr sz="5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9" name="Google Shape;29;p5"/>
          <p:cNvSpPr txBox="1"/>
          <p:nvPr>
            <p:ph idx="1" type="body"/>
          </p:nvPr>
        </p:nvSpPr>
        <p:spPr>
          <a:xfrm>
            <a:off x="998220" y="3977535"/>
            <a:ext cx="12618721" cy="130016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228600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rgbClr val="888888"/>
              </a:buClr>
              <a:buSzPts val="2080"/>
              <a:buNone/>
              <a:defRPr sz="2080">
                <a:solidFill>
                  <a:srgbClr val="888888"/>
                </a:solidFill>
              </a:defRPr>
            </a:lvl1pPr>
            <a:lvl2pPr indent="-228600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rgbClr val="888888"/>
              </a:buClr>
              <a:buSzPts val="1733"/>
              <a:buNone/>
              <a:defRPr sz="1733">
                <a:solidFill>
                  <a:srgbClr val="888888"/>
                </a:solidFill>
              </a:defRPr>
            </a:lvl2pPr>
            <a:lvl3pPr indent="-22860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rgbClr val="888888"/>
              </a:buClr>
              <a:buSzPts val="1560"/>
              <a:buNone/>
              <a:defRPr sz="1560">
                <a:solidFill>
                  <a:srgbClr val="888888"/>
                </a:solidFill>
              </a:defRPr>
            </a:lvl3pPr>
            <a:lvl4pPr indent="-228600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rgbClr val="888888"/>
              </a:buClr>
              <a:buSzPts val="1387"/>
              <a:buNone/>
              <a:defRPr sz="1387">
                <a:solidFill>
                  <a:srgbClr val="888888"/>
                </a:solidFill>
              </a:defRPr>
            </a:lvl4pPr>
            <a:lvl5pPr indent="-228600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rgbClr val="888888"/>
              </a:buClr>
              <a:buSzPts val="1387"/>
              <a:buNone/>
              <a:defRPr sz="1387">
                <a:solidFill>
                  <a:srgbClr val="888888"/>
                </a:solidFill>
              </a:defRPr>
            </a:lvl5pPr>
            <a:lvl6pPr indent="-228600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rgbClr val="888888"/>
              </a:buClr>
              <a:buSzPts val="1387"/>
              <a:buNone/>
              <a:defRPr sz="1387">
                <a:solidFill>
                  <a:srgbClr val="888888"/>
                </a:solidFill>
              </a:defRPr>
            </a:lvl6pPr>
            <a:lvl7pPr indent="-228600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rgbClr val="888888"/>
              </a:buClr>
              <a:buSzPts val="1387"/>
              <a:buNone/>
              <a:defRPr sz="1387">
                <a:solidFill>
                  <a:srgbClr val="888888"/>
                </a:solidFill>
              </a:defRPr>
            </a:lvl7pPr>
            <a:lvl8pPr indent="-228600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rgbClr val="888888"/>
              </a:buClr>
              <a:buSzPts val="1387"/>
              <a:buNone/>
              <a:defRPr sz="1387">
                <a:solidFill>
                  <a:srgbClr val="888888"/>
                </a:solidFill>
              </a:defRPr>
            </a:lvl8pPr>
            <a:lvl9pPr indent="-228600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rgbClr val="888888"/>
              </a:buClr>
              <a:buSzPts val="1387"/>
              <a:buNone/>
              <a:defRPr sz="1387"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30" name="Google Shape;30;p5"/>
          <p:cNvSpPr txBox="1"/>
          <p:nvPr>
            <p:ph idx="10" type="dt"/>
          </p:nvPr>
        </p:nvSpPr>
        <p:spPr>
          <a:xfrm>
            <a:off x="100584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1" name="Google Shape;31;p5"/>
          <p:cNvSpPr txBox="1"/>
          <p:nvPr>
            <p:ph idx="11" type="ftr"/>
          </p:nvPr>
        </p:nvSpPr>
        <p:spPr>
          <a:xfrm>
            <a:off x="4846320" y="5508837"/>
            <a:ext cx="493776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2" name="Google Shape;32;p5"/>
          <p:cNvSpPr txBox="1"/>
          <p:nvPr>
            <p:ph idx="12" type="sldNum"/>
          </p:nvPr>
        </p:nvSpPr>
        <p:spPr>
          <a:xfrm>
            <a:off x="1033272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Two Content" type="twoObj">
  <p:cSld name="TWO_OBJECTS">
    <p:spTree>
      <p:nvGrpSpPr>
        <p:cNvPr id="33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6"/>
          <p:cNvSpPr txBox="1"/>
          <p:nvPr>
            <p:ph type="title"/>
          </p:nvPr>
        </p:nvSpPr>
        <p:spPr>
          <a:xfrm>
            <a:off x="1005840" y="316442"/>
            <a:ext cx="12618721" cy="114882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6"/>
          <p:cNvSpPr txBox="1"/>
          <p:nvPr>
            <p:ph idx="1" type="body"/>
          </p:nvPr>
        </p:nvSpPr>
        <p:spPr>
          <a:xfrm>
            <a:off x="1005840" y="1582208"/>
            <a:ext cx="6217920" cy="377116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342900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6" name="Google Shape;36;p6"/>
          <p:cNvSpPr txBox="1"/>
          <p:nvPr>
            <p:ph idx="2" type="body"/>
          </p:nvPr>
        </p:nvSpPr>
        <p:spPr>
          <a:xfrm>
            <a:off x="7406640" y="1582208"/>
            <a:ext cx="6217920" cy="377116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342900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7" name="Google Shape;37;p6"/>
          <p:cNvSpPr txBox="1"/>
          <p:nvPr>
            <p:ph idx="10" type="dt"/>
          </p:nvPr>
        </p:nvSpPr>
        <p:spPr>
          <a:xfrm>
            <a:off x="100584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8" name="Google Shape;38;p6"/>
          <p:cNvSpPr txBox="1"/>
          <p:nvPr>
            <p:ph idx="11" type="ftr"/>
          </p:nvPr>
        </p:nvSpPr>
        <p:spPr>
          <a:xfrm>
            <a:off x="4846320" y="5508837"/>
            <a:ext cx="493776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9" name="Google Shape;39;p6"/>
          <p:cNvSpPr txBox="1"/>
          <p:nvPr>
            <p:ph idx="12" type="sldNum"/>
          </p:nvPr>
        </p:nvSpPr>
        <p:spPr>
          <a:xfrm>
            <a:off x="1033272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Comparison" type="twoTxTwoObj">
  <p:cSld name="TWO_OBJECTS_WITH_TEXT">
    <p:spTree>
      <p:nvGrpSpPr>
        <p:cNvPr id="40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7"/>
          <p:cNvSpPr txBox="1"/>
          <p:nvPr>
            <p:ph type="title"/>
          </p:nvPr>
        </p:nvSpPr>
        <p:spPr>
          <a:xfrm>
            <a:off x="1007746" y="316442"/>
            <a:ext cx="12618721" cy="114882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2" name="Google Shape;42;p7"/>
          <p:cNvSpPr txBox="1"/>
          <p:nvPr>
            <p:ph idx="1" type="body"/>
          </p:nvPr>
        </p:nvSpPr>
        <p:spPr>
          <a:xfrm>
            <a:off x="1007746" y="1457008"/>
            <a:ext cx="6189344" cy="71405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-228600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2080"/>
              <a:buNone/>
              <a:defRPr b="1" sz="2080"/>
            </a:lvl1pPr>
            <a:lvl2pPr indent="-228600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None/>
              <a:defRPr b="1" sz="1733"/>
            </a:lvl2pPr>
            <a:lvl3pPr indent="-22860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560"/>
              <a:buNone/>
              <a:defRPr b="1" sz="1560"/>
            </a:lvl3pPr>
            <a:lvl4pPr indent="-228600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b="1" sz="1387"/>
            </a:lvl4pPr>
            <a:lvl5pPr indent="-228600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b="1" sz="1387"/>
            </a:lvl5pPr>
            <a:lvl6pPr indent="-228600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b="1" sz="1387"/>
            </a:lvl6pPr>
            <a:lvl7pPr indent="-228600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b="1" sz="1387"/>
            </a:lvl7pPr>
            <a:lvl8pPr indent="-228600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b="1" sz="1387"/>
            </a:lvl8pPr>
            <a:lvl9pPr indent="-228600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b="1" sz="1387"/>
            </a:lvl9pPr>
          </a:lstStyle>
          <a:p/>
        </p:txBody>
      </p:sp>
      <p:sp>
        <p:nvSpPr>
          <p:cNvPr id="43" name="Google Shape;43;p7"/>
          <p:cNvSpPr txBox="1"/>
          <p:nvPr>
            <p:ph idx="2" type="body"/>
          </p:nvPr>
        </p:nvSpPr>
        <p:spPr>
          <a:xfrm>
            <a:off x="1007746" y="2171065"/>
            <a:ext cx="6189344" cy="319331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342900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4" name="Google Shape;44;p7"/>
          <p:cNvSpPr txBox="1"/>
          <p:nvPr>
            <p:ph idx="3" type="body"/>
          </p:nvPr>
        </p:nvSpPr>
        <p:spPr>
          <a:xfrm>
            <a:off x="7406640" y="1457008"/>
            <a:ext cx="6219826" cy="71405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-228600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2080"/>
              <a:buNone/>
              <a:defRPr b="1" sz="2080"/>
            </a:lvl1pPr>
            <a:lvl2pPr indent="-228600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None/>
              <a:defRPr b="1" sz="1733"/>
            </a:lvl2pPr>
            <a:lvl3pPr indent="-22860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560"/>
              <a:buNone/>
              <a:defRPr b="1" sz="1560"/>
            </a:lvl3pPr>
            <a:lvl4pPr indent="-228600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b="1" sz="1387"/>
            </a:lvl4pPr>
            <a:lvl5pPr indent="-228600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b="1" sz="1387"/>
            </a:lvl5pPr>
            <a:lvl6pPr indent="-228600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b="1" sz="1387"/>
            </a:lvl6pPr>
            <a:lvl7pPr indent="-228600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b="1" sz="1387"/>
            </a:lvl7pPr>
            <a:lvl8pPr indent="-228600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b="1" sz="1387"/>
            </a:lvl8pPr>
            <a:lvl9pPr indent="-228600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b="1" sz="1387"/>
            </a:lvl9pPr>
          </a:lstStyle>
          <a:p/>
        </p:txBody>
      </p:sp>
      <p:sp>
        <p:nvSpPr>
          <p:cNvPr id="45" name="Google Shape;45;p7"/>
          <p:cNvSpPr txBox="1"/>
          <p:nvPr>
            <p:ph idx="4" type="body"/>
          </p:nvPr>
        </p:nvSpPr>
        <p:spPr>
          <a:xfrm>
            <a:off x="7406640" y="2171065"/>
            <a:ext cx="6219826" cy="319331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342900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6" name="Google Shape;46;p7"/>
          <p:cNvSpPr txBox="1"/>
          <p:nvPr>
            <p:ph idx="10" type="dt"/>
          </p:nvPr>
        </p:nvSpPr>
        <p:spPr>
          <a:xfrm>
            <a:off x="100584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7" name="Google Shape;47;p7"/>
          <p:cNvSpPr txBox="1"/>
          <p:nvPr>
            <p:ph idx="11" type="ftr"/>
          </p:nvPr>
        </p:nvSpPr>
        <p:spPr>
          <a:xfrm>
            <a:off x="4846320" y="5508837"/>
            <a:ext cx="493776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8" name="Google Shape;48;p7"/>
          <p:cNvSpPr txBox="1"/>
          <p:nvPr>
            <p:ph idx="12" type="sldNum"/>
          </p:nvPr>
        </p:nvSpPr>
        <p:spPr>
          <a:xfrm>
            <a:off x="1033272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Title Only" type="titleOnly">
  <p:cSld name="TITLE_ONLY">
    <p:spTree>
      <p:nvGrpSpPr>
        <p:cNvPr id="49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8"/>
          <p:cNvSpPr txBox="1"/>
          <p:nvPr>
            <p:ph type="title"/>
          </p:nvPr>
        </p:nvSpPr>
        <p:spPr>
          <a:xfrm>
            <a:off x="1005840" y="316442"/>
            <a:ext cx="12618721" cy="114882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1" name="Google Shape;51;p8"/>
          <p:cNvSpPr txBox="1"/>
          <p:nvPr>
            <p:ph idx="10" type="dt"/>
          </p:nvPr>
        </p:nvSpPr>
        <p:spPr>
          <a:xfrm>
            <a:off x="100584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8"/>
          <p:cNvSpPr txBox="1"/>
          <p:nvPr>
            <p:ph idx="11" type="ftr"/>
          </p:nvPr>
        </p:nvSpPr>
        <p:spPr>
          <a:xfrm>
            <a:off x="4846320" y="5508837"/>
            <a:ext cx="493776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3" name="Google Shape;53;p8"/>
          <p:cNvSpPr txBox="1"/>
          <p:nvPr>
            <p:ph idx="12" type="sldNum"/>
          </p:nvPr>
        </p:nvSpPr>
        <p:spPr>
          <a:xfrm>
            <a:off x="1033272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Content with Caption" type="objTx">
  <p:cSld name="OBJECT_WITH_CAPTION_TEXT">
    <p:spTree>
      <p:nvGrpSpPr>
        <p:cNvPr id="54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9"/>
          <p:cNvSpPr txBox="1"/>
          <p:nvPr>
            <p:ph type="title"/>
          </p:nvPr>
        </p:nvSpPr>
        <p:spPr>
          <a:xfrm>
            <a:off x="1007746" y="396240"/>
            <a:ext cx="4718684" cy="138684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773"/>
              <a:buFont typeface="Calibri"/>
              <a:buNone/>
              <a:defRPr sz="2773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6" name="Google Shape;56;p9"/>
          <p:cNvSpPr txBox="1"/>
          <p:nvPr>
            <p:ph idx="1" type="body"/>
          </p:nvPr>
        </p:nvSpPr>
        <p:spPr>
          <a:xfrm>
            <a:off x="6219826" y="855769"/>
            <a:ext cx="7406640" cy="422380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404685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2773"/>
              <a:buChar char="•"/>
              <a:defRPr sz="2773"/>
            </a:lvl1pPr>
            <a:lvl2pPr indent="-382714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2427"/>
              <a:buChar char="•"/>
              <a:defRPr sz="2427"/>
            </a:lvl2pPr>
            <a:lvl3pPr indent="-36068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2080"/>
              <a:buChar char="•"/>
              <a:defRPr sz="2080"/>
            </a:lvl3pPr>
            <a:lvl4pPr indent="-338645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Char char="•"/>
              <a:defRPr sz="1733"/>
            </a:lvl4pPr>
            <a:lvl5pPr indent="-338645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Char char="•"/>
              <a:defRPr sz="1733"/>
            </a:lvl5pPr>
            <a:lvl6pPr indent="-338645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Char char="•"/>
              <a:defRPr sz="1733"/>
            </a:lvl6pPr>
            <a:lvl7pPr indent="-338645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Char char="•"/>
              <a:defRPr sz="1733"/>
            </a:lvl7pPr>
            <a:lvl8pPr indent="-338645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Char char="•"/>
              <a:defRPr sz="1733"/>
            </a:lvl8pPr>
            <a:lvl9pPr indent="-338645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Char char="•"/>
              <a:defRPr sz="1733"/>
            </a:lvl9pPr>
          </a:lstStyle>
          <a:p/>
        </p:txBody>
      </p:sp>
      <p:sp>
        <p:nvSpPr>
          <p:cNvPr id="57" name="Google Shape;57;p9"/>
          <p:cNvSpPr txBox="1"/>
          <p:nvPr>
            <p:ph idx="2" type="body"/>
          </p:nvPr>
        </p:nvSpPr>
        <p:spPr>
          <a:xfrm>
            <a:off x="1007746" y="1783080"/>
            <a:ext cx="4718684" cy="3303376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228600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sz="1387"/>
            </a:lvl1pPr>
            <a:lvl2pPr indent="-228600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213"/>
              <a:buNone/>
              <a:defRPr sz="1213"/>
            </a:lvl2pPr>
            <a:lvl3pPr indent="-22860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040"/>
              <a:buNone/>
              <a:defRPr sz="1040"/>
            </a:lvl3pPr>
            <a:lvl4pPr indent="-228600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867"/>
              <a:buNone/>
              <a:defRPr sz="867"/>
            </a:lvl4pPr>
            <a:lvl5pPr indent="-228600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867"/>
              <a:buNone/>
              <a:defRPr sz="867"/>
            </a:lvl5pPr>
            <a:lvl6pPr indent="-228600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867"/>
              <a:buNone/>
              <a:defRPr sz="867"/>
            </a:lvl6pPr>
            <a:lvl7pPr indent="-228600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867"/>
              <a:buNone/>
              <a:defRPr sz="867"/>
            </a:lvl7pPr>
            <a:lvl8pPr indent="-228600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867"/>
              <a:buNone/>
              <a:defRPr sz="867"/>
            </a:lvl8pPr>
            <a:lvl9pPr indent="-228600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867"/>
              <a:buNone/>
              <a:defRPr sz="867"/>
            </a:lvl9pPr>
          </a:lstStyle>
          <a:p/>
        </p:txBody>
      </p:sp>
      <p:sp>
        <p:nvSpPr>
          <p:cNvPr id="58" name="Google Shape;58;p9"/>
          <p:cNvSpPr txBox="1"/>
          <p:nvPr>
            <p:ph idx="10" type="dt"/>
          </p:nvPr>
        </p:nvSpPr>
        <p:spPr>
          <a:xfrm>
            <a:off x="100584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9" name="Google Shape;59;p9"/>
          <p:cNvSpPr txBox="1"/>
          <p:nvPr>
            <p:ph idx="11" type="ftr"/>
          </p:nvPr>
        </p:nvSpPr>
        <p:spPr>
          <a:xfrm>
            <a:off x="4846320" y="5508837"/>
            <a:ext cx="493776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0" name="Google Shape;60;p9"/>
          <p:cNvSpPr txBox="1"/>
          <p:nvPr>
            <p:ph idx="12" type="sldNum"/>
          </p:nvPr>
        </p:nvSpPr>
        <p:spPr>
          <a:xfrm>
            <a:off x="1033272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Picture with Caption" type="picTx">
  <p:cSld name="PICTURE_WITH_CAPTION_TEXT">
    <p:spTree>
      <p:nvGrpSpPr>
        <p:cNvPr id="6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0"/>
          <p:cNvSpPr txBox="1"/>
          <p:nvPr>
            <p:ph type="title"/>
          </p:nvPr>
        </p:nvSpPr>
        <p:spPr>
          <a:xfrm>
            <a:off x="1007746" y="396240"/>
            <a:ext cx="4718684" cy="138684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773"/>
              <a:buFont typeface="Calibri"/>
              <a:buNone/>
              <a:defRPr sz="2773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3" name="Google Shape;63;p10"/>
          <p:cNvSpPr/>
          <p:nvPr>
            <p:ph idx="2" type="pic"/>
          </p:nvPr>
        </p:nvSpPr>
        <p:spPr>
          <a:xfrm>
            <a:off x="6219826" y="855769"/>
            <a:ext cx="7406640" cy="422380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lvl="0" marR="0" rtl="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2773"/>
              <a:buFont typeface="Arial"/>
              <a:buNone/>
              <a:defRPr b="0" i="0" sz="2773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2427"/>
              <a:buFont typeface="Arial"/>
              <a:buNone/>
              <a:defRPr b="0" i="0" sz="2427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2080"/>
              <a:buFont typeface="Arial"/>
              <a:buNone/>
              <a:defRPr b="0" i="0" sz="208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Font typeface="Arial"/>
              <a:buNone/>
              <a:defRPr b="0" i="0" sz="1733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Font typeface="Arial"/>
              <a:buNone/>
              <a:defRPr b="0" i="0" sz="1733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Font typeface="Arial"/>
              <a:buNone/>
              <a:defRPr b="0" i="0" sz="1733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Font typeface="Arial"/>
              <a:buNone/>
              <a:defRPr b="0" i="0" sz="1733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Font typeface="Arial"/>
              <a:buNone/>
              <a:defRPr b="0" i="0" sz="1733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Font typeface="Arial"/>
              <a:buNone/>
              <a:defRPr b="0" i="0" sz="1733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64" name="Google Shape;64;p10"/>
          <p:cNvSpPr txBox="1"/>
          <p:nvPr>
            <p:ph idx="1" type="body"/>
          </p:nvPr>
        </p:nvSpPr>
        <p:spPr>
          <a:xfrm>
            <a:off x="1007746" y="1783080"/>
            <a:ext cx="4718684" cy="3303376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228600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sz="1387"/>
            </a:lvl1pPr>
            <a:lvl2pPr indent="-228600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213"/>
              <a:buNone/>
              <a:defRPr sz="1213"/>
            </a:lvl2pPr>
            <a:lvl3pPr indent="-22860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040"/>
              <a:buNone/>
              <a:defRPr sz="1040"/>
            </a:lvl3pPr>
            <a:lvl4pPr indent="-228600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867"/>
              <a:buNone/>
              <a:defRPr sz="867"/>
            </a:lvl4pPr>
            <a:lvl5pPr indent="-228600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867"/>
              <a:buNone/>
              <a:defRPr sz="867"/>
            </a:lvl5pPr>
            <a:lvl6pPr indent="-228600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867"/>
              <a:buNone/>
              <a:defRPr sz="867"/>
            </a:lvl6pPr>
            <a:lvl7pPr indent="-228600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867"/>
              <a:buNone/>
              <a:defRPr sz="867"/>
            </a:lvl7pPr>
            <a:lvl8pPr indent="-228600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867"/>
              <a:buNone/>
              <a:defRPr sz="867"/>
            </a:lvl8pPr>
            <a:lvl9pPr indent="-228600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867"/>
              <a:buNone/>
              <a:defRPr sz="867"/>
            </a:lvl9pPr>
          </a:lstStyle>
          <a:p/>
        </p:txBody>
      </p:sp>
      <p:sp>
        <p:nvSpPr>
          <p:cNvPr id="65" name="Google Shape;65;p10"/>
          <p:cNvSpPr txBox="1"/>
          <p:nvPr>
            <p:ph idx="10" type="dt"/>
          </p:nvPr>
        </p:nvSpPr>
        <p:spPr>
          <a:xfrm>
            <a:off x="100584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6" name="Google Shape;66;p10"/>
          <p:cNvSpPr txBox="1"/>
          <p:nvPr>
            <p:ph idx="11" type="ftr"/>
          </p:nvPr>
        </p:nvSpPr>
        <p:spPr>
          <a:xfrm>
            <a:off x="4846320" y="5508837"/>
            <a:ext cx="493776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10"/>
          <p:cNvSpPr txBox="1"/>
          <p:nvPr>
            <p:ph idx="12" type="sldNum"/>
          </p:nvPr>
        </p:nvSpPr>
        <p:spPr>
          <a:xfrm>
            <a:off x="1033272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1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>
  <p:cSld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1005840" y="316442"/>
            <a:ext cx="12618721" cy="114882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813"/>
              <a:buFont typeface="Calibri"/>
              <a:buNone/>
              <a:defRPr b="0" i="0" sz="3813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1005840" y="1582208"/>
            <a:ext cx="12618721" cy="377116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382714" lvl="0" marL="457200" marR="0" rtl="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2427"/>
              <a:buFont typeface="Arial"/>
              <a:buChar char="•"/>
              <a:defRPr b="0" i="0" sz="2427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360680" lvl="1" marL="914400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2080"/>
              <a:buFont typeface="Arial"/>
              <a:buChar char="•"/>
              <a:defRPr b="0" i="0" sz="208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338645" lvl="2" marL="1371600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Font typeface="Arial"/>
              <a:buChar char="•"/>
              <a:defRPr b="0" i="0" sz="1733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327660" lvl="3" marL="1828800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560"/>
              <a:buFont typeface="Arial"/>
              <a:buChar char="•"/>
              <a:defRPr b="0" i="0" sz="156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327660" lvl="4" marL="2286000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560"/>
              <a:buFont typeface="Arial"/>
              <a:buChar char="•"/>
              <a:defRPr b="0" i="0" sz="156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327660" lvl="5" marL="2743200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560"/>
              <a:buFont typeface="Arial"/>
              <a:buChar char="•"/>
              <a:defRPr b="0" i="0" sz="156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327660" lvl="6" marL="3200400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560"/>
              <a:buFont typeface="Arial"/>
              <a:buChar char="•"/>
              <a:defRPr b="0" i="0" sz="156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327659" lvl="7" marL="3657600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560"/>
              <a:buFont typeface="Arial"/>
              <a:buChar char="•"/>
              <a:defRPr b="0" i="0" sz="156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327659" lvl="8" marL="4114800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560"/>
              <a:buFont typeface="Arial"/>
              <a:buChar char="•"/>
              <a:defRPr b="0" i="0" sz="156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0" type="dt"/>
          </p:nvPr>
        </p:nvSpPr>
        <p:spPr>
          <a:xfrm>
            <a:off x="100584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04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9" name="Google Shape;9;p1"/>
          <p:cNvSpPr txBox="1"/>
          <p:nvPr>
            <p:ph idx="11" type="ftr"/>
          </p:nvPr>
        </p:nvSpPr>
        <p:spPr>
          <a:xfrm>
            <a:off x="4846320" y="5508837"/>
            <a:ext cx="493776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ct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04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0" name="Google Shape;10;p1"/>
          <p:cNvSpPr txBox="1"/>
          <p:nvPr>
            <p:ph idx="12" type="sldNum"/>
          </p:nvPr>
        </p:nvSpPr>
        <p:spPr>
          <a:xfrm>
            <a:off x="1033272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spcBef>
                <a:spcPts val="0"/>
              </a:spcBef>
              <a:buNone/>
              <a:defRPr b="0" i="0" sz="104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rtl="0" algn="r">
              <a:spcBef>
                <a:spcPts val="0"/>
              </a:spcBef>
              <a:buNone/>
              <a:defRPr b="0" i="0" sz="104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rtl="0" algn="r">
              <a:spcBef>
                <a:spcPts val="0"/>
              </a:spcBef>
              <a:buNone/>
              <a:defRPr b="0" i="0" sz="104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rtl="0" algn="r">
              <a:spcBef>
                <a:spcPts val="0"/>
              </a:spcBef>
              <a:buNone/>
              <a:defRPr b="0" i="0" sz="104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rtl="0" algn="r">
              <a:spcBef>
                <a:spcPts val="0"/>
              </a:spcBef>
              <a:buNone/>
              <a:defRPr b="0" i="0" sz="104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rtl="0" algn="r">
              <a:spcBef>
                <a:spcPts val="0"/>
              </a:spcBef>
              <a:buNone/>
              <a:defRPr b="0" i="0" sz="104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rtl="0" algn="r">
              <a:spcBef>
                <a:spcPts val="0"/>
              </a:spcBef>
              <a:buNone/>
              <a:defRPr b="0" i="0" sz="104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rtl="0" algn="r">
              <a:spcBef>
                <a:spcPts val="0"/>
              </a:spcBef>
              <a:buNone/>
              <a:defRPr b="0" i="0" sz="104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rtl="0" algn="r">
              <a:spcBef>
                <a:spcPts val="0"/>
              </a:spcBef>
              <a:buNone/>
              <a:defRPr b="0" i="0" sz="104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Google Shape;84;p13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0075841" y="114300"/>
            <a:ext cx="4490170" cy="5686425"/>
          </a:xfrm>
          <a:prstGeom prst="rect">
            <a:avLst/>
          </a:prstGeom>
          <a:noFill/>
          <a:ln>
            <a:noFill/>
          </a:ln>
        </p:spPr>
      </p:pic>
      <p:sp>
        <p:nvSpPr>
          <p:cNvPr id="85" name="Google Shape;85;p13"/>
          <p:cNvSpPr txBox="1"/>
          <p:nvPr/>
        </p:nvSpPr>
        <p:spPr>
          <a:xfrm>
            <a:off x="56750" y="300943"/>
            <a:ext cx="226031" cy="27699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200" u="none" cap="none" strike="noStrik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a</a:t>
            </a:r>
            <a:endParaRPr/>
          </a:p>
        </p:txBody>
      </p:sp>
      <p:graphicFrame>
        <p:nvGraphicFramePr>
          <p:cNvPr id="86" name="Google Shape;86;p13"/>
          <p:cNvGraphicFramePr/>
          <p:nvPr/>
        </p:nvGraphicFramePr>
        <p:xfrm>
          <a:off x="56750" y="847401"/>
          <a:ext cx="3000000" cy="3000000"/>
        </p:xfrm>
        <a:graphic>
          <a:graphicData uri="http://schemas.openxmlformats.org/drawingml/2006/table">
            <a:tbl>
              <a:tblPr>
                <a:noFill/>
                <a:tableStyleId>{23C1CB89-ECA3-4FAA-A7E1-106BF05B6F16}</a:tableStyleId>
              </a:tblPr>
              <a:tblGrid>
                <a:gridCol w="977950"/>
                <a:gridCol w="655675"/>
                <a:gridCol w="866800"/>
                <a:gridCol w="944600"/>
                <a:gridCol w="722350"/>
                <a:gridCol w="1600275"/>
                <a:gridCol w="1189100"/>
                <a:gridCol w="1211325"/>
                <a:gridCol w="1233550"/>
              </a:tblGrid>
              <a:tr h="56070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hromosome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osition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redicted Impact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Reference Allele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lternate Allele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redicted Effect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% Homozygous Reference</a:t>
                      </a:r>
                      <a:r>
                        <a:rPr b="1" baseline="3000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i</a:t>
                      </a: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 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% Heterozygous Lines</a:t>
                      </a:r>
                      <a:r>
                        <a:rPr b="1" baseline="3000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i</a:t>
                      </a:r>
                      <a:endParaRPr b="1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% Homozygous Alternate</a:t>
                      </a:r>
                      <a:r>
                        <a:rPr b="1" baseline="3000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i</a:t>
                      </a:r>
                      <a:endParaRPr b="1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43390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hr07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934028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ODERATE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issense variant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9.7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.6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67.7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</a:tr>
              <a:tr h="4669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hr07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934031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ODERATE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G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issense variant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86.8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.6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1.6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43390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hr07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934040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ODERATE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Calibri"/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issense variant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8.5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.9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8.6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</a:tr>
              <a:tr h="43390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hr07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934099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ODERATE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Calibri"/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issense variant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9.4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.8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7.8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43390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hr07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934128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ODERATE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Calibri"/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issense variant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9.4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7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9.9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</a:tr>
              <a:tr h="43390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hr07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934129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ODERATE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G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Calibri"/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issense variant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9.7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7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9.6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43390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hr07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934187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ODERATE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issense variant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87.8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.1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0.1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</a:tr>
              <a:tr h="4506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hr07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934291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ODERATE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CCG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Disruptive in frame deletion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2.2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.3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4.5</a:t>
                      </a:r>
                      <a:endParaRPr/>
                    </a:p>
                  </a:txBody>
                  <a:tcPr marT="7800" marB="0" marR="7800" marL="78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</a:tbl>
          </a:graphicData>
        </a:graphic>
      </p:graphicFrame>
      <p:sp>
        <p:nvSpPr>
          <p:cNvPr id="87" name="Google Shape;87;p13"/>
          <p:cNvSpPr txBox="1"/>
          <p:nvPr/>
        </p:nvSpPr>
        <p:spPr>
          <a:xfrm>
            <a:off x="10075841" y="300943"/>
            <a:ext cx="226031" cy="27699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200" u="none" cap="none" strike="noStrik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b</a:t>
            </a:r>
            <a:endParaRPr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